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sldIdLst>
    <p:sldId id="256" r:id="rId2"/>
    <p:sldId id="260" r:id="rId3"/>
    <p:sldId id="259" r:id="rId4"/>
    <p:sldId id="261" r:id="rId5"/>
    <p:sldId id="263" r:id="rId6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257"/>
    <p:restoredTop sz="94648"/>
  </p:normalViewPr>
  <p:slideViewPr>
    <p:cSldViewPr snapToGrid="0">
      <p:cViewPr varScale="1">
        <p:scale>
          <a:sx n="84" d="100"/>
          <a:sy n="84" d="100"/>
        </p:scale>
        <p:origin x="2968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AE46E-64EF-4045-B51E-B6569313AC1B}" type="datetimeFigureOut">
              <a:rPr lang="en-US" smtClean="0"/>
              <a:t>3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E35DF-88A5-DA42-961F-9F09FEFC8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96790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AE46E-64EF-4045-B51E-B6569313AC1B}" type="datetimeFigureOut">
              <a:rPr lang="en-US" smtClean="0"/>
              <a:t>3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E35DF-88A5-DA42-961F-9F09FEFC8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41292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AE46E-64EF-4045-B51E-B6569313AC1B}" type="datetimeFigureOut">
              <a:rPr lang="en-US" smtClean="0"/>
              <a:t>3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E35DF-88A5-DA42-961F-9F09FEFC8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10043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AE46E-64EF-4045-B51E-B6569313AC1B}" type="datetimeFigureOut">
              <a:rPr lang="en-US" smtClean="0"/>
              <a:t>3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E35DF-88A5-DA42-961F-9F09FEFC8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12064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AE46E-64EF-4045-B51E-B6569313AC1B}" type="datetimeFigureOut">
              <a:rPr lang="en-US" smtClean="0"/>
              <a:t>3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E35DF-88A5-DA42-961F-9F09FEFC8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61948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AE46E-64EF-4045-B51E-B6569313AC1B}" type="datetimeFigureOut">
              <a:rPr lang="en-US" smtClean="0"/>
              <a:t>3/1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E35DF-88A5-DA42-961F-9F09FEFC8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43693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AE46E-64EF-4045-B51E-B6569313AC1B}" type="datetimeFigureOut">
              <a:rPr lang="en-US" smtClean="0"/>
              <a:t>3/13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E35DF-88A5-DA42-961F-9F09FEFC8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56990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AE46E-64EF-4045-B51E-B6569313AC1B}" type="datetimeFigureOut">
              <a:rPr lang="en-US" smtClean="0"/>
              <a:t>3/13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E35DF-88A5-DA42-961F-9F09FEFC8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47163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AE46E-64EF-4045-B51E-B6569313AC1B}" type="datetimeFigureOut">
              <a:rPr lang="en-US" smtClean="0"/>
              <a:t>3/13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E35DF-88A5-DA42-961F-9F09FEFC8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91882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AE46E-64EF-4045-B51E-B6569313AC1B}" type="datetimeFigureOut">
              <a:rPr lang="en-US" smtClean="0"/>
              <a:t>3/1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E35DF-88A5-DA42-961F-9F09FEFC8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03285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AE46E-64EF-4045-B51E-B6569313AC1B}" type="datetimeFigureOut">
              <a:rPr lang="en-US" smtClean="0"/>
              <a:t>3/1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E35DF-88A5-DA42-961F-9F09FEFC8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29224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CAE46E-64EF-4045-B51E-B6569313AC1B}" type="datetimeFigureOut">
              <a:rPr lang="en-US" smtClean="0"/>
              <a:t>3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7E35DF-88A5-DA42-961F-9F09FEFC8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95866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11912E73-6B09-1B54-075A-442DEE10621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12394" y="1285876"/>
            <a:ext cx="3685032" cy="7311726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97A94A0C-61F8-DB9A-7826-2442A8D1177A}"/>
              </a:ext>
            </a:extLst>
          </p:cNvPr>
          <p:cNvSpPr txBox="1"/>
          <p:nvPr/>
        </p:nvSpPr>
        <p:spPr>
          <a:xfrm>
            <a:off x="2653621" y="670560"/>
            <a:ext cx="15720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PFC Creatine</a:t>
            </a:r>
          </a:p>
        </p:txBody>
      </p:sp>
    </p:spTree>
    <p:extLst>
      <p:ext uri="{BB962C8B-B14F-4D97-AF65-F5344CB8AC3E}">
        <p14:creationId xmlns:p14="http://schemas.microsoft.com/office/powerpoint/2010/main" val="11889693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EEE4F68-1F1E-EB03-0EEF-B8B7E357EC6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61160" y="1283780"/>
            <a:ext cx="3569462" cy="246164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928DB9D-5D2B-701A-4037-33425B593EBF}"/>
              </a:ext>
            </a:extLst>
          </p:cNvPr>
          <p:cNvSpPr txBox="1"/>
          <p:nvPr/>
        </p:nvSpPr>
        <p:spPr>
          <a:xfrm>
            <a:off x="2682240" y="914400"/>
            <a:ext cx="16153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LPFC Creatine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1BEB0FC6-C196-CB29-D695-409B834D70F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81340" y="4928153"/>
            <a:ext cx="3693287" cy="246164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D0FEB30-336B-E693-33D5-28C32B1C6AA1}"/>
              </a:ext>
            </a:extLst>
          </p:cNvPr>
          <p:cNvSpPr txBox="1"/>
          <p:nvPr/>
        </p:nvSpPr>
        <p:spPr>
          <a:xfrm>
            <a:off x="2392680" y="4465320"/>
            <a:ext cx="22746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asal Ganglia Creatine</a:t>
            </a:r>
          </a:p>
        </p:txBody>
      </p:sp>
    </p:spTree>
    <p:extLst>
      <p:ext uri="{BB962C8B-B14F-4D97-AF65-F5344CB8AC3E}">
        <p14:creationId xmlns:p14="http://schemas.microsoft.com/office/powerpoint/2010/main" val="1260177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7F34D163-ED11-A286-94EA-911D6B559A1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74812" y="1049230"/>
            <a:ext cx="3508375" cy="2091817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60C4837B-E321-EB02-2968-390C6001E06A}"/>
              </a:ext>
            </a:extLst>
          </p:cNvPr>
          <p:cNvSpPr txBox="1"/>
          <p:nvPr/>
        </p:nvSpPr>
        <p:spPr>
          <a:xfrm>
            <a:off x="2468880" y="640080"/>
            <a:ext cx="18723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alamic Creatine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A19D66CA-6A43-C828-EE99-5C091E870D0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27060" y="6679990"/>
            <a:ext cx="3569462" cy="135382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721C60CB-1D67-3CAB-0DCE-65CDC336C5E6}"/>
              </a:ext>
            </a:extLst>
          </p:cNvPr>
          <p:cNvSpPr txBox="1"/>
          <p:nvPr/>
        </p:nvSpPr>
        <p:spPr>
          <a:xfrm>
            <a:off x="1920240" y="6233160"/>
            <a:ext cx="30154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rontal White Matter Creatine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B0735880-140F-FB7D-4454-1503729574A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00200" y="3967743"/>
            <a:ext cx="3654674" cy="176479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001D9D8-20EA-AC95-70EC-93B8927940F3}"/>
              </a:ext>
            </a:extLst>
          </p:cNvPr>
          <p:cNvSpPr txBox="1"/>
          <p:nvPr/>
        </p:nvSpPr>
        <p:spPr>
          <a:xfrm>
            <a:off x="2316480" y="3535680"/>
            <a:ext cx="22679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ippocampal Creatine</a:t>
            </a:r>
          </a:p>
        </p:txBody>
      </p:sp>
    </p:spTree>
    <p:extLst>
      <p:ext uri="{BB962C8B-B14F-4D97-AF65-F5344CB8AC3E}">
        <p14:creationId xmlns:p14="http://schemas.microsoft.com/office/powerpoint/2010/main" val="27857845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867D078A-4D81-3934-2D13-642724D7118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18030" y="1305112"/>
            <a:ext cx="5021940" cy="2798064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B46AF16C-A03F-DF4C-2E57-B8F2915A1E2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16868" y="4984048"/>
            <a:ext cx="5024762" cy="3483864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B8B6F075-AD94-446D-B44A-727A59741D18}"/>
              </a:ext>
            </a:extLst>
          </p:cNvPr>
          <p:cNvSpPr txBox="1"/>
          <p:nvPr/>
        </p:nvSpPr>
        <p:spPr>
          <a:xfrm>
            <a:off x="2148840" y="594360"/>
            <a:ext cx="257525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ippocampal NAA/water </a:t>
            </a:r>
          </a:p>
          <a:p>
            <a:pPr algn="ctr"/>
            <a:r>
              <a:rPr lang="en-US" dirty="0"/>
              <a:t>regression with LN T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495C880-9516-AEF9-53EC-18CE78ACDB80}"/>
              </a:ext>
            </a:extLst>
          </p:cNvPr>
          <p:cNvSpPr txBox="1"/>
          <p:nvPr/>
        </p:nvSpPr>
        <p:spPr>
          <a:xfrm>
            <a:off x="2087880" y="4267200"/>
            <a:ext cx="279595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ippocampal NAA/creatine </a:t>
            </a:r>
          </a:p>
          <a:p>
            <a:pPr algn="ctr"/>
            <a:r>
              <a:rPr lang="en-US" dirty="0"/>
              <a:t>regression with LN TE</a:t>
            </a:r>
          </a:p>
        </p:txBody>
      </p:sp>
    </p:spTree>
    <p:extLst>
      <p:ext uri="{BB962C8B-B14F-4D97-AF65-F5344CB8AC3E}">
        <p14:creationId xmlns:p14="http://schemas.microsoft.com/office/powerpoint/2010/main" val="31332011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EB3B5A4-B94E-B341-CE8F-E68CA658D5E5}"/>
              </a:ext>
            </a:extLst>
          </p:cNvPr>
          <p:cNvSpPr txBox="1"/>
          <p:nvPr/>
        </p:nvSpPr>
        <p:spPr>
          <a:xfrm>
            <a:off x="1511407" y="1005840"/>
            <a:ext cx="3880678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Frontal White Matter NAA </a:t>
            </a:r>
          </a:p>
          <a:p>
            <a:pPr algn="ctr"/>
            <a:r>
              <a:rPr lang="en-US" dirty="0"/>
              <a:t>regression with LN TE,</a:t>
            </a:r>
          </a:p>
          <a:p>
            <a:pPr algn="ctr"/>
            <a:r>
              <a:rPr lang="en-US" dirty="0"/>
              <a:t>normalized to water (w) or creatine (</a:t>
            </a:r>
            <a:r>
              <a:rPr lang="en-US" dirty="0" err="1"/>
              <a:t>cr</a:t>
            </a:r>
            <a:r>
              <a:rPr lang="en-US" dirty="0"/>
              <a:t>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5607155-3A08-A59F-F475-D66F2C6389A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1040" y="2078558"/>
            <a:ext cx="5490985" cy="40416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358317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11</TotalTime>
  <Words>51</Words>
  <Application>Microsoft Macintosh PowerPoint</Application>
  <PresentationFormat>Letter Paper (8.5x11 in)</PresentationFormat>
  <Paragraphs>13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ichard J Maddock</dc:creator>
  <cp:lastModifiedBy>Richard J Maddock</cp:lastModifiedBy>
  <cp:revision>19</cp:revision>
  <dcterms:created xsi:type="dcterms:W3CDTF">2022-12-30T18:17:40Z</dcterms:created>
  <dcterms:modified xsi:type="dcterms:W3CDTF">2023-03-13T19:37:03Z</dcterms:modified>
</cp:coreProperties>
</file>